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963525" cy="972343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55E362-19AD-451F-A6F2-D3457ABA658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47280" y="388440"/>
            <a:ext cx="11666520" cy="1621080"/>
          </a:xfrm>
          <a:prstGeom prst="rect">
            <a:avLst/>
          </a:prstGeom>
          <a:noFill/>
          <a:ln w="0">
            <a:noFill/>
          </a:ln>
        </p:spPr>
        <p:txBody>
          <a:bodyPr lIns="129600" rIns="129600" tIns="64800" bIns="64800" anchor="ctr">
            <a:noAutofit/>
          </a:bodyPr>
          <a:p>
            <a:pPr indent="0" algn="ctr">
              <a:buNone/>
              <a:tabLst>
                <a:tab algn="l" pos="0"/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47280" y="2268360"/>
            <a:ext cx="11666520" cy="3060000"/>
          </a:xfrm>
          <a:prstGeom prst="rect">
            <a:avLst/>
          </a:prstGeom>
          <a:noFill/>
          <a:ln w="0">
            <a:noFill/>
          </a:ln>
        </p:spPr>
        <p:txBody>
          <a:bodyPr lIns="129600" rIns="129600" tIns="64800" bIns="6480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47280" y="5619600"/>
            <a:ext cx="11666520" cy="3060000"/>
          </a:xfrm>
          <a:prstGeom prst="rect">
            <a:avLst/>
          </a:prstGeom>
          <a:noFill/>
          <a:ln w="0">
            <a:noFill/>
          </a:ln>
        </p:spPr>
        <p:txBody>
          <a:bodyPr lIns="129600" rIns="129600" tIns="64800" bIns="6480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CE399B-10E6-478D-8F45-D5FD96D562D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47280" y="388440"/>
            <a:ext cx="11666520" cy="1621080"/>
          </a:xfrm>
          <a:prstGeom prst="rect">
            <a:avLst/>
          </a:prstGeom>
          <a:noFill/>
          <a:ln w="0">
            <a:noFill/>
          </a:ln>
        </p:spPr>
        <p:txBody>
          <a:bodyPr lIns="129600" rIns="129600" tIns="64800" bIns="64800" anchor="ctr">
            <a:noAutofit/>
          </a:bodyPr>
          <a:p>
            <a:pPr indent="0" algn="ctr">
              <a:buNone/>
              <a:tabLst>
                <a:tab algn="l" pos="0"/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47280" y="2268360"/>
            <a:ext cx="5693040" cy="3060000"/>
          </a:xfrm>
          <a:prstGeom prst="rect">
            <a:avLst/>
          </a:prstGeom>
          <a:noFill/>
          <a:ln w="0">
            <a:noFill/>
          </a:ln>
        </p:spPr>
        <p:txBody>
          <a:bodyPr lIns="129600" rIns="129600" tIns="64800" bIns="6480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625440" y="2268360"/>
            <a:ext cx="5693040" cy="3060000"/>
          </a:xfrm>
          <a:prstGeom prst="rect">
            <a:avLst/>
          </a:prstGeom>
          <a:noFill/>
          <a:ln w="0">
            <a:noFill/>
          </a:ln>
        </p:spPr>
        <p:txBody>
          <a:bodyPr lIns="129600" rIns="129600" tIns="64800" bIns="6480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47280" y="5619600"/>
            <a:ext cx="5693040" cy="3060000"/>
          </a:xfrm>
          <a:prstGeom prst="rect">
            <a:avLst/>
          </a:prstGeom>
          <a:noFill/>
          <a:ln w="0">
            <a:noFill/>
          </a:ln>
        </p:spPr>
        <p:txBody>
          <a:bodyPr lIns="129600" rIns="129600" tIns="64800" bIns="6480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625440" y="5619600"/>
            <a:ext cx="5693040" cy="3060000"/>
          </a:xfrm>
          <a:prstGeom prst="rect">
            <a:avLst/>
          </a:prstGeom>
          <a:noFill/>
          <a:ln w="0">
            <a:noFill/>
          </a:ln>
        </p:spPr>
        <p:txBody>
          <a:bodyPr lIns="129600" rIns="129600" tIns="64800" bIns="6480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8D9D30-2F0A-4C71-8CE4-E880D72ED86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47280" y="388440"/>
            <a:ext cx="11666520" cy="1621080"/>
          </a:xfrm>
          <a:prstGeom prst="rect">
            <a:avLst/>
          </a:prstGeom>
          <a:noFill/>
          <a:ln w="0">
            <a:noFill/>
          </a:ln>
        </p:spPr>
        <p:txBody>
          <a:bodyPr lIns="129600" rIns="129600" tIns="64800" bIns="64800" anchor="ctr">
            <a:noAutofit/>
          </a:bodyPr>
          <a:p>
            <a:pPr indent="0" algn="ctr">
              <a:buNone/>
              <a:tabLst>
                <a:tab algn="l" pos="0"/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47280" y="2268360"/>
            <a:ext cx="3756240" cy="3060000"/>
          </a:xfrm>
          <a:prstGeom prst="rect">
            <a:avLst/>
          </a:prstGeom>
          <a:noFill/>
          <a:ln w="0">
            <a:noFill/>
          </a:ln>
        </p:spPr>
        <p:txBody>
          <a:bodyPr lIns="129600" rIns="129600" tIns="64800" bIns="6480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591800" y="2268360"/>
            <a:ext cx="3756240" cy="3060000"/>
          </a:xfrm>
          <a:prstGeom prst="rect">
            <a:avLst/>
          </a:prstGeom>
          <a:noFill/>
          <a:ln w="0">
            <a:noFill/>
          </a:ln>
        </p:spPr>
        <p:txBody>
          <a:bodyPr lIns="129600" rIns="129600" tIns="64800" bIns="6480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8536320" y="2268360"/>
            <a:ext cx="3756240" cy="3060000"/>
          </a:xfrm>
          <a:prstGeom prst="rect">
            <a:avLst/>
          </a:prstGeom>
          <a:noFill/>
          <a:ln w="0">
            <a:noFill/>
          </a:ln>
        </p:spPr>
        <p:txBody>
          <a:bodyPr lIns="129600" rIns="129600" tIns="64800" bIns="6480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47280" y="5619600"/>
            <a:ext cx="3756240" cy="3060000"/>
          </a:xfrm>
          <a:prstGeom prst="rect">
            <a:avLst/>
          </a:prstGeom>
          <a:noFill/>
          <a:ln w="0">
            <a:noFill/>
          </a:ln>
        </p:spPr>
        <p:txBody>
          <a:bodyPr lIns="129600" rIns="129600" tIns="64800" bIns="6480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591800" y="5619600"/>
            <a:ext cx="3756240" cy="3060000"/>
          </a:xfrm>
          <a:prstGeom prst="rect">
            <a:avLst/>
          </a:prstGeom>
          <a:noFill/>
          <a:ln w="0">
            <a:noFill/>
          </a:ln>
        </p:spPr>
        <p:txBody>
          <a:bodyPr lIns="129600" rIns="129600" tIns="64800" bIns="6480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8536320" y="5619600"/>
            <a:ext cx="3756240" cy="3060000"/>
          </a:xfrm>
          <a:prstGeom prst="rect">
            <a:avLst/>
          </a:prstGeom>
          <a:noFill/>
          <a:ln w="0">
            <a:noFill/>
          </a:ln>
        </p:spPr>
        <p:txBody>
          <a:bodyPr lIns="129600" rIns="129600" tIns="64800" bIns="6480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FD8334-A6AC-4552-9611-9BD690C1407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47280" y="388440"/>
            <a:ext cx="11666520" cy="1621080"/>
          </a:xfrm>
          <a:prstGeom prst="rect">
            <a:avLst/>
          </a:prstGeom>
          <a:noFill/>
          <a:ln w="0">
            <a:noFill/>
          </a:ln>
        </p:spPr>
        <p:txBody>
          <a:bodyPr lIns="129600" rIns="129600" tIns="64800" bIns="64800" anchor="ctr">
            <a:noAutofit/>
          </a:bodyPr>
          <a:p>
            <a:pPr indent="0" algn="ctr">
              <a:buNone/>
              <a:tabLst>
                <a:tab algn="l" pos="0"/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47280" y="2268360"/>
            <a:ext cx="11666520" cy="6415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125"/>
              </a:spcBef>
              <a:buNone/>
              <a:tabLst>
                <a:tab algn="l" pos="0"/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33E35C-FBA2-4623-A092-B8CFDDA7155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47280" y="388440"/>
            <a:ext cx="11666520" cy="1621080"/>
          </a:xfrm>
          <a:prstGeom prst="rect">
            <a:avLst/>
          </a:prstGeom>
          <a:noFill/>
          <a:ln w="0">
            <a:noFill/>
          </a:ln>
        </p:spPr>
        <p:txBody>
          <a:bodyPr lIns="129600" rIns="129600" tIns="64800" bIns="64800" anchor="ctr">
            <a:noAutofit/>
          </a:bodyPr>
          <a:p>
            <a:pPr indent="0" algn="ctr">
              <a:buNone/>
              <a:tabLst>
                <a:tab algn="l" pos="0"/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47280" y="2268360"/>
            <a:ext cx="11666520" cy="6415200"/>
          </a:xfrm>
          <a:prstGeom prst="rect">
            <a:avLst/>
          </a:prstGeom>
          <a:noFill/>
          <a:ln w="0">
            <a:noFill/>
          </a:ln>
        </p:spPr>
        <p:txBody>
          <a:bodyPr lIns="129600" rIns="129600" tIns="64800" bIns="6480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2D709A-883E-4719-BEC9-DBCBEF67BD4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47280" y="388440"/>
            <a:ext cx="11666520" cy="1621080"/>
          </a:xfrm>
          <a:prstGeom prst="rect">
            <a:avLst/>
          </a:prstGeom>
          <a:noFill/>
          <a:ln w="0">
            <a:noFill/>
          </a:ln>
        </p:spPr>
        <p:txBody>
          <a:bodyPr lIns="129600" rIns="129600" tIns="64800" bIns="64800" anchor="ctr">
            <a:noAutofit/>
          </a:bodyPr>
          <a:p>
            <a:pPr indent="0" algn="ctr">
              <a:buNone/>
              <a:tabLst>
                <a:tab algn="l" pos="0"/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47280" y="2268360"/>
            <a:ext cx="5693040" cy="6415200"/>
          </a:xfrm>
          <a:prstGeom prst="rect">
            <a:avLst/>
          </a:prstGeom>
          <a:noFill/>
          <a:ln w="0">
            <a:noFill/>
          </a:ln>
        </p:spPr>
        <p:txBody>
          <a:bodyPr lIns="129600" rIns="129600" tIns="64800" bIns="6480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625440" y="2268360"/>
            <a:ext cx="5693040" cy="6415200"/>
          </a:xfrm>
          <a:prstGeom prst="rect">
            <a:avLst/>
          </a:prstGeom>
          <a:noFill/>
          <a:ln w="0">
            <a:noFill/>
          </a:ln>
        </p:spPr>
        <p:txBody>
          <a:bodyPr lIns="129600" rIns="129600" tIns="64800" bIns="6480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68FD86-45B4-4AFD-B1AC-3F759EE9219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47280" y="388440"/>
            <a:ext cx="11666520" cy="1621080"/>
          </a:xfrm>
          <a:prstGeom prst="rect">
            <a:avLst/>
          </a:prstGeom>
          <a:noFill/>
          <a:ln w="0">
            <a:noFill/>
          </a:ln>
        </p:spPr>
        <p:txBody>
          <a:bodyPr lIns="129600" rIns="129600" tIns="64800" bIns="64800" anchor="ctr">
            <a:noAutofit/>
          </a:bodyPr>
          <a:p>
            <a:pPr indent="0" algn="ctr">
              <a:buNone/>
              <a:tabLst>
                <a:tab algn="l" pos="0"/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45CE88-748D-4382-9358-33BE5ED013C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47280" y="388440"/>
            <a:ext cx="11666520" cy="7515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125"/>
              </a:spcBef>
              <a:tabLst>
                <a:tab algn="l" pos="0"/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DBE058-F2B7-47EB-BFA2-3375493FC52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47280" y="388440"/>
            <a:ext cx="11666520" cy="1621080"/>
          </a:xfrm>
          <a:prstGeom prst="rect">
            <a:avLst/>
          </a:prstGeom>
          <a:noFill/>
          <a:ln w="0">
            <a:noFill/>
          </a:ln>
        </p:spPr>
        <p:txBody>
          <a:bodyPr lIns="129600" rIns="129600" tIns="64800" bIns="64800" anchor="ctr">
            <a:noAutofit/>
          </a:bodyPr>
          <a:p>
            <a:pPr indent="0" algn="ctr">
              <a:buNone/>
              <a:tabLst>
                <a:tab algn="l" pos="0"/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47280" y="2268360"/>
            <a:ext cx="5693040" cy="3060000"/>
          </a:xfrm>
          <a:prstGeom prst="rect">
            <a:avLst/>
          </a:prstGeom>
          <a:noFill/>
          <a:ln w="0">
            <a:noFill/>
          </a:ln>
        </p:spPr>
        <p:txBody>
          <a:bodyPr lIns="129600" rIns="129600" tIns="64800" bIns="6480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625440" y="2268360"/>
            <a:ext cx="5693040" cy="6415200"/>
          </a:xfrm>
          <a:prstGeom prst="rect">
            <a:avLst/>
          </a:prstGeom>
          <a:noFill/>
          <a:ln w="0">
            <a:noFill/>
          </a:ln>
        </p:spPr>
        <p:txBody>
          <a:bodyPr lIns="129600" rIns="129600" tIns="64800" bIns="6480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47280" y="5619600"/>
            <a:ext cx="5693040" cy="3060000"/>
          </a:xfrm>
          <a:prstGeom prst="rect">
            <a:avLst/>
          </a:prstGeom>
          <a:noFill/>
          <a:ln w="0">
            <a:noFill/>
          </a:ln>
        </p:spPr>
        <p:txBody>
          <a:bodyPr lIns="129600" rIns="129600" tIns="64800" bIns="6480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2F9591-AD71-4B01-A5C2-E7A52C15F64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47280" y="388440"/>
            <a:ext cx="11666520" cy="1621080"/>
          </a:xfrm>
          <a:prstGeom prst="rect">
            <a:avLst/>
          </a:prstGeom>
          <a:noFill/>
          <a:ln w="0">
            <a:noFill/>
          </a:ln>
        </p:spPr>
        <p:txBody>
          <a:bodyPr lIns="129600" rIns="129600" tIns="64800" bIns="64800" anchor="ctr">
            <a:noAutofit/>
          </a:bodyPr>
          <a:p>
            <a:pPr indent="0" algn="ctr">
              <a:buNone/>
              <a:tabLst>
                <a:tab algn="l" pos="0"/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47280" y="2268360"/>
            <a:ext cx="5693040" cy="6415200"/>
          </a:xfrm>
          <a:prstGeom prst="rect">
            <a:avLst/>
          </a:prstGeom>
          <a:noFill/>
          <a:ln w="0">
            <a:noFill/>
          </a:ln>
        </p:spPr>
        <p:txBody>
          <a:bodyPr lIns="129600" rIns="129600" tIns="64800" bIns="6480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625440" y="2268360"/>
            <a:ext cx="5693040" cy="3060000"/>
          </a:xfrm>
          <a:prstGeom prst="rect">
            <a:avLst/>
          </a:prstGeom>
          <a:noFill/>
          <a:ln w="0">
            <a:noFill/>
          </a:ln>
        </p:spPr>
        <p:txBody>
          <a:bodyPr lIns="129600" rIns="129600" tIns="64800" bIns="6480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625440" y="5619600"/>
            <a:ext cx="5693040" cy="3060000"/>
          </a:xfrm>
          <a:prstGeom prst="rect">
            <a:avLst/>
          </a:prstGeom>
          <a:noFill/>
          <a:ln w="0">
            <a:noFill/>
          </a:ln>
        </p:spPr>
        <p:txBody>
          <a:bodyPr lIns="129600" rIns="129600" tIns="64800" bIns="6480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1DD9AA-CF5E-4254-9FC0-DA51C6B35C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47280" y="388440"/>
            <a:ext cx="11666520" cy="1621080"/>
          </a:xfrm>
          <a:prstGeom prst="rect">
            <a:avLst/>
          </a:prstGeom>
          <a:noFill/>
          <a:ln w="0">
            <a:noFill/>
          </a:ln>
        </p:spPr>
        <p:txBody>
          <a:bodyPr lIns="129600" rIns="129600" tIns="64800" bIns="64800" anchor="ctr">
            <a:noAutofit/>
          </a:bodyPr>
          <a:p>
            <a:pPr indent="0" algn="ctr">
              <a:buNone/>
              <a:tabLst>
                <a:tab algn="l" pos="0"/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47280" y="2268360"/>
            <a:ext cx="5693040" cy="3060000"/>
          </a:xfrm>
          <a:prstGeom prst="rect">
            <a:avLst/>
          </a:prstGeom>
          <a:noFill/>
          <a:ln w="0">
            <a:noFill/>
          </a:ln>
        </p:spPr>
        <p:txBody>
          <a:bodyPr lIns="129600" rIns="129600" tIns="64800" bIns="6480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625440" y="2268360"/>
            <a:ext cx="5693040" cy="3060000"/>
          </a:xfrm>
          <a:prstGeom prst="rect">
            <a:avLst/>
          </a:prstGeom>
          <a:noFill/>
          <a:ln w="0">
            <a:noFill/>
          </a:ln>
        </p:spPr>
        <p:txBody>
          <a:bodyPr lIns="129600" rIns="129600" tIns="64800" bIns="6480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47280" y="5619600"/>
            <a:ext cx="11666520" cy="3060000"/>
          </a:xfrm>
          <a:prstGeom prst="rect">
            <a:avLst/>
          </a:prstGeom>
          <a:noFill/>
          <a:ln w="0">
            <a:noFill/>
          </a:ln>
        </p:spPr>
        <p:txBody>
          <a:bodyPr lIns="129600" rIns="129600" tIns="64800" bIns="6480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36CB4F-5100-4892-A7A4-32090A1554E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47280" y="388440"/>
            <a:ext cx="11666520" cy="1621080"/>
          </a:xfrm>
          <a:prstGeom prst="rect">
            <a:avLst/>
          </a:prstGeom>
          <a:noFill/>
          <a:ln w="0">
            <a:noFill/>
          </a:ln>
        </p:spPr>
        <p:txBody>
          <a:bodyPr lIns="129600" rIns="129600" tIns="64800" bIns="64800" anchor="ctr">
            <a:noAutofit/>
          </a:bodyPr>
          <a:p>
            <a:pPr indent="0" algn="ctr">
              <a:buNone/>
              <a:tabLst>
                <a:tab algn="l" pos="0"/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47280" y="2268360"/>
            <a:ext cx="11666520" cy="6415200"/>
          </a:xfrm>
          <a:prstGeom prst="rect">
            <a:avLst/>
          </a:prstGeom>
          <a:noFill/>
          <a:ln w="0">
            <a:noFill/>
          </a:ln>
        </p:spPr>
        <p:txBody>
          <a:bodyPr lIns="129600" rIns="129600" tIns="64800" bIns="64800" anchor="t">
            <a:normAutofit/>
          </a:bodyPr>
          <a:p>
            <a:pPr marL="485640" indent="-485640">
              <a:spcBef>
                <a:spcPts val="1125"/>
              </a:spcBef>
              <a:buClr>
                <a:srgbClr val="000000"/>
              </a:buClr>
              <a:buFont typeface="Arial"/>
              <a:buChar char="•"/>
              <a:tabLst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r>
              <a:rPr b="0" lang="en-US" sz="45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  <a:p>
            <a:pPr lvl="1" marL="1052640" indent="-405000">
              <a:spcBef>
                <a:spcPts val="1125"/>
              </a:spcBef>
              <a:buClr>
                <a:srgbClr val="000000"/>
              </a:buClr>
              <a:buFont typeface="Arial"/>
              <a:buChar char="–"/>
              <a:tabLst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r>
              <a:rPr b="0" lang="en-US" sz="45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  <a:p>
            <a:pPr lvl="2" marL="1619280" indent="-324000">
              <a:spcBef>
                <a:spcPts val="1125"/>
              </a:spcBef>
              <a:buClr>
                <a:srgbClr val="000000"/>
              </a:buClr>
              <a:buFont typeface="Arial"/>
              <a:buChar char="•"/>
              <a:tabLst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r>
              <a:rPr b="0" lang="en-US" sz="45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  <a:p>
            <a:pPr lvl="3" marL="2266920" indent="-323640">
              <a:spcBef>
                <a:spcPts val="1125"/>
              </a:spcBef>
              <a:buClr>
                <a:srgbClr val="000000"/>
              </a:buClr>
              <a:buFont typeface="Arial"/>
              <a:buChar char="–"/>
              <a:tabLst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r>
              <a:rPr b="0" lang="en-US" sz="45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  <a:p>
            <a:pPr lvl="4" marL="2916360" indent="-324000">
              <a:spcBef>
                <a:spcPts val="1125"/>
              </a:spcBef>
              <a:buClr>
                <a:srgbClr val="000000"/>
              </a:buClr>
              <a:buFont typeface="Arial"/>
              <a:buChar char="»"/>
              <a:tabLst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r>
              <a:rPr b="0" lang="en-US" sz="45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  <a:p>
            <a:pPr lvl="5" marL="2916360" indent="-324000">
              <a:spcBef>
                <a:spcPts val="1125"/>
              </a:spcBef>
              <a:buClr>
                <a:srgbClr val="000000"/>
              </a:buClr>
              <a:buFont typeface="Arial"/>
              <a:buChar char="»"/>
              <a:tabLst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r>
              <a:rPr b="0" lang="en-US" sz="45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  <a:p>
            <a:pPr lvl="6" marL="2916360" indent="-324000">
              <a:spcBef>
                <a:spcPts val="1125"/>
              </a:spcBef>
              <a:buClr>
                <a:srgbClr val="000000"/>
              </a:buClr>
              <a:buFont typeface="Arial"/>
              <a:buChar char="»"/>
              <a:tabLst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r>
              <a:rPr b="0" lang="en-US" sz="45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47280" y="9010440"/>
            <a:ext cx="3024360" cy="517320"/>
          </a:xfrm>
          <a:prstGeom prst="rect">
            <a:avLst/>
          </a:prstGeom>
          <a:noFill/>
          <a:ln w="0">
            <a:noFill/>
          </a:ln>
        </p:spPr>
        <p:txBody>
          <a:bodyPr lIns="129600" rIns="129600" tIns="64800" bIns="64800" anchor="ctr">
            <a:noAutofit/>
          </a:bodyPr>
          <a:lstStyle>
            <a:lvl1pPr indent="0">
              <a:buNone/>
              <a:tabLst>
                <a:tab algn="l" pos="0"/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  <a:defRPr b="0" lang="zh-CN" sz="17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r>
              <a:rPr b="0" lang="zh-CN" sz="17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428720" y="9010440"/>
            <a:ext cx="4103640" cy="517320"/>
          </a:xfrm>
          <a:prstGeom prst="rect">
            <a:avLst/>
          </a:prstGeom>
          <a:noFill/>
          <a:ln w="0">
            <a:noFill/>
          </a:ln>
        </p:spPr>
        <p:txBody>
          <a:bodyPr lIns="129600" rIns="129600" tIns="64800" bIns="64800" anchor="ctr">
            <a:noAutofit/>
          </a:bodyPr>
          <a:p>
            <a:pPr indent="0">
              <a:buNone/>
              <a:tabLst>
                <a:tab algn="l" pos="0"/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9290160" y="9010440"/>
            <a:ext cx="3024000" cy="517320"/>
          </a:xfrm>
          <a:prstGeom prst="rect">
            <a:avLst/>
          </a:prstGeom>
          <a:noFill/>
          <a:ln w="0">
            <a:noFill/>
          </a:ln>
        </p:spPr>
        <p:txBody>
          <a:bodyPr lIns="129600" rIns="129600" tIns="64800" bIns="64800" anchor="ctr">
            <a:noAutofit/>
          </a:bodyPr>
          <a:lstStyle>
            <a:lvl1pPr indent="0" algn="r">
              <a:buNone/>
              <a:tabLst>
                <a:tab algn="l" pos="0"/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  <a:defRPr b="0" lang="zh-CN" sz="17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fld id="{BFF3198D-AB64-4B28-A200-23142CCF8A94}" type="slidenum">
              <a:rPr b="0" lang="zh-CN" sz="17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7" descr=""/>
          <p:cNvPicPr/>
          <p:nvPr/>
        </p:nvPicPr>
        <p:blipFill>
          <a:blip r:embed="rId1"/>
          <a:stretch/>
        </p:blipFill>
        <p:spPr>
          <a:xfrm>
            <a:off x="6851520" y="5292720"/>
            <a:ext cx="5965920" cy="2960640"/>
          </a:xfrm>
          <a:prstGeom prst="rect">
            <a:avLst/>
          </a:prstGeom>
          <a:ln w="0">
            <a:noFill/>
          </a:ln>
        </p:spPr>
      </p:pic>
      <p:grpSp>
        <p:nvGrpSpPr>
          <p:cNvPr id="42" name="组合 161"/>
          <p:cNvGrpSpPr/>
          <p:nvPr/>
        </p:nvGrpSpPr>
        <p:grpSpPr>
          <a:xfrm>
            <a:off x="6840360" y="658800"/>
            <a:ext cx="6035760" cy="4105080"/>
            <a:chOff x="6840360" y="658800"/>
            <a:chExt cx="6035760" cy="4105080"/>
          </a:xfrm>
        </p:grpSpPr>
        <p:pic>
          <p:nvPicPr>
            <p:cNvPr id="43" name="Picture 5" descr=""/>
            <p:cNvPicPr/>
            <p:nvPr/>
          </p:nvPicPr>
          <p:blipFill>
            <a:blip r:embed="rId2"/>
            <a:stretch/>
          </p:blipFill>
          <p:spPr>
            <a:xfrm>
              <a:off x="6840360" y="658800"/>
              <a:ext cx="6035760" cy="292608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44" name="组合 55"/>
            <p:cNvGrpSpPr/>
            <p:nvPr/>
          </p:nvGrpSpPr>
          <p:grpSpPr>
            <a:xfrm>
              <a:off x="6846480" y="730800"/>
              <a:ext cx="5976000" cy="4033080"/>
              <a:chOff x="6846480" y="730800"/>
              <a:chExt cx="5976000" cy="4033080"/>
            </a:xfrm>
          </p:grpSpPr>
          <p:grpSp>
            <p:nvGrpSpPr>
              <p:cNvPr id="45" name="组合 23"/>
              <p:cNvGrpSpPr/>
              <p:nvPr/>
            </p:nvGrpSpPr>
            <p:grpSpPr>
              <a:xfrm>
                <a:off x="6846480" y="3402720"/>
                <a:ext cx="1833480" cy="1359720"/>
                <a:chOff x="6846480" y="3402720"/>
                <a:chExt cx="1833480" cy="1359720"/>
              </a:xfrm>
            </p:grpSpPr>
            <p:sp>
              <p:nvSpPr>
                <p:cNvPr id="46" name="文本框 11"/>
                <p:cNvSpPr/>
                <p:nvPr/>
              </p:nvSpPr>
              <p:spPr>
                <a:xfrm rot="18600000">
                  <a:off x="6892560" y="3695400"/>
                  <a:ext cx="8650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si-Ctrl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7" name="文本框 11"/>
                <p:cNvSpPr/>
                <p:nvPr/>
              </p:nvSpPr>
              <p:spPr>
                <a:xfrm rot="18600000">
                  <a:off x="6711480" y="3859560"/>
                  <a:ext cx="131472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si-Ctrl + IL1β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8" name="文本框 11"/>
                <p:cNvSpPr/>
                <p:nvPr/>
              </p:nvSpPr>
              <p:spPr>
                <a:xfrm rot="18600000">
                  <a:off x="6725160" y="3955320"/>
                  <a:ext cx="154620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si-Ctrl + TNFα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9" name="文本框 14"/>
                <p:cNvSpPr/>
                <p:nvPr/>
              </p:nvSpPr>
              <p:spPr>
                <a:xfrm rot="18600000">
                  <a:off x="7171200" y="3923640"/>
                  <a:ext cx="148284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si-BRD2+ IL1β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0" name="文本框 14"/>
                <p:cNvSpPr/>
                <p:nvPr/>
              </p:nvSpPr>
              <p:spPr>
                <a:xfrm rot="18600000">
                  <a:off x="7361640" y="3930480"/>
                  <a:ext cx="148284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si-BRD2+ TNFα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1" name="文本框 14"/>
                <p:cNvSpPr/>
                <p:nvPr/>
              </p:nvSpPr>
              <p:spPr>
                <a:xfrm rot="18600000">
                  <a:off x="7443360" y="3709800"/>
                  <a:ext cx="91764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si-BRD2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52" name="组合 45"/>
              <p:cNvGrpSpPr/>
              <p:nvPr/>
            </p:nvGrpSpPr>
            <p:grpSpPr>
              <a:xfrm>
                <a:off x="7560000" y="731160"/>
                <a:ext cx="1080360" cy="261360"/>
                <a:chOff x="7560000" y="731160"/>
                <a:chExt cx="1080360" cy="261360"/>
              </a:xfrm>
            </p:grpSpPr>
            <p:sp>
              <p:nvSpPr>
                <p:cNvPr id="53" name="直接连接符 19"/>
                <p:cNvSpPr/>
                <p:nvPr/>
              </p:nvSpPr>
              <p:spPr>
                <a:xfrm>
                  <a:off x="7560000" y="947160"/>
                  <a:ext cx="1080360" cy="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4" name="矩形 22"/>
                <p:cNvSpPr/>
                <p:nvPr/>
              </p:nvSpPr>
              <p:spPr>
                <a:xfrm>
                  <a:off x="7853760" y="731160"/>
                  <a:ext cx="49176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BRD2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55" name="组合 24"/>
              <p:cNvGrpSpPr/>
              <p:nvPr/>
            </p:nvGrpSpPr>
            <p:grpSpPr>
              <a:xfrm>
                <a:off x="8222400" y="3404160"/>
                <a:ext cx="1833480" cy="1359720"/>
                <a:chOff x="8222400" y="3404160"/>
                <a:chExt cx="1833480" cy="1359720"/>
              </a:xfrm>
            </p:grpSpPr>
            <p:sp>
              <p:nvSpPr>
                <p:cNvPr id="56" name="文本框 11"/>
                <p:cNvSpPr/>
                <p:nvPr/>
              </p:nvSpPr>
              <p:spPr>
                <a:xfrm rot="18600000">
                  <a:off x="8268480" y="3696840"/>
                  <a:ext cx="8650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si-Ctrl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7" name="文本框 11"/>
                <p:cNvSpPr/>
                <p:nvPr/>
              </p:nvSpPr>
              <p:spPr>
                <a:xfrm rot="18600000">
                  <a:off x="8087400" y="3861000"/>
                  <a:ext cx="131472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si-Ctrl + IL1β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8" name="文本框 11"/>
                <p:cNvSpPr/>
                <p:nvPr/>
              </p:nvSpPr>
              <p:spPr>
                <a:xfrm rot="18600000">
                  <a:off x="8101080" y="3956760"/>
                  <a:ext cx="154620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si-Ctrl + TNFα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9" name="文本框 14"/>
                <p:cNvSpPr/>
                <p:nvPr/>
              </p:nvSpPr>
              <p:spPr>
                <a:xfrm rot="18600000">
                  <a:off x="8547120" y="3925080"/>
                  <a:ext cx="148284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si-BRD2+ IL1β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0" name="文本框 14"/>
                <p:cNvSpPr/>
                <p:nvPr/>
              </p:nvSpPr>
              <p:spPr>
                <a:xfrm rot="18600000">
                  <a:off x="8737560" y="3931920"/>
                  <a:ext cx="148284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si-BRD2+ TNFα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1" name="文本框 14"/>
                <p:cNvSpPr/>
                <p:nvPr/>
              </p:nvSpPr>
              <p:spPr>
                <a:xfrm rot="18600000">
                  <a:off x="8819280" y="3711240"/>
                  <a:ext cx="91764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si-BRD2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62" name="组合 31"/>
              <p:cNvGrpSpPr/>
              <p:nvPr/>
            </p:nvGrpSpPr>
            <p:grpSpPr>
              <a:xfrm>
                <a:off x="9605880" y="3404160"/>
                <a:ext cx="1833480" cy="1359720"/>
                <a:chOff x="9605880" y="3404160"/>
                <a:chExt cx="1833480" cy="1359720"/>
              </a:xfrm>
            </p:grpSpPr>
            <p:sp>
              <p:nvSpPr>
                <p:cNvPr id="63" name="文本框 11"/>
                <p:cNvSpPr/>
                <p:nvPr/>
              </p:nvSpPr>
              <p:spPr>
                <a:xfrm rot="18600000">
                  <a:off x="9651960" y="3696840"/>
                  <a:ext cx="8650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si-Ctrl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4" name="文本框 11"/>
                <p:cNvSpPr/>
                <p:nvPr/>
              </p:nvSpPr>
              <p:spPr>
                <a:xfrm rot="18600000">
                  <a:off x="9470880" y="3861000"/>
                  <a:ext cx="131472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si-Ctrl + IL1β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5" name="文本框 11"/>
                <p:cNvSpPr/>
                <p:nvPr/>
              </p:nvSpPr>
              <p:spPr>
                <a:xfrm rot="18600000">
                  <a:off x="9484560" y="3956760"/>
                  <a:ext cx="154620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si-Ctrl + TNFα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6" name="文本框 14"/>
                <p:cNvSpPr/>
                <p:nvPr/>
              </p:nvSpPr>
              <p:spPr>
                <a:xfrm rot="18600000">
                  <a:off x="9930600" y="3925080"/>
                  <a:ext cx="148284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si-BRD2+ IL1β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7" name="文本框 14"/>
                <p:cNvSpPr/>
                <p:nvPr/>
              </p:nvSpPr>
              <p:spPr>
                <a:xfrm rot="18600000">
                  <a:off x="10121040" y="3931920"/>
                  <a:ext cx="148284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si-BRD2+ TNFα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8" name="文本框 14"/>
                <p:cNvSpPr/>
                <p:nvPr/>
              </p:nvSpPr>
              <p:spPr>
                <a:xfrm rot="18600000">
                  <a:off x="10202760" y="3711240"/>
                  <a:ext cx="91764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si-BRD2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69" name="组合 38"/>
              <p:cNvGrpSpPr/>
              <p:nvPr/>
            </p:nvGrpSpPr>
            <p:grpSpPr>
              <a:xfrm>
                <a:off x="10989000" y="3404160"/>
                <a:ext cx="1833480" cy="1359720"/>
                <a:chOff x="10989000" y="3404160"/>
                <a:chExt cx="1833480" cy="1359720"/>
              </a:xfrm>
            </p:grpSpPr>
            <p:sp>
              <p:nvSpPr>
                <p:cNvPr id="70" name="文本框 11"/>
                <p:cNvSpPr/>
                <p:nvPr/>
              </p:nvSpPr>
              <p:spPr>
                <a:xfrm rot="18600000">
                  <a:off x="11035080" y="3696840"/>
                  <a:ext cx="8650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si-Ctrl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1" name="文本框 11"/>
                <p:cNvSpPr/>
                <p:nvPr/>
              </p:nvSpPr>
              <p:spPr>
                <a:xfrm rot="18600000">
                  <a:off x="10854000" y="3861000"/>
                  <a:ext cx="131472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si-Ctrl + IL1β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2" name="文本框 11"/>
                <p:cNvSpPr/>
                <p:nvPr/>
              </p:nvSpPr>
              <p:spPr>
                <a:xfrm rot="18600000">
                  <a:off x="10867680" y="3956760"/>
                  <a:ext cx="154620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si-Ctrl + TNFα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3" name="文本框 14"/>
                <p:cNvSpPr/>
                <p:nvPr/>
              </p:nvSpPr>
              <p:spPr>
                <a:xfrm rot="18600000">
                  <a:off x="11313720" y="3925080"/>
                  <a:ext cx="148284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si-BRD2+ IL1β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4" name="文本框 14"/>
                <p:cNvSpPr/>
                <p:nvPr/>
              </p:nvSpPr>
              <p:spPr>
                <a:xfrm rot="18600000">
                  <a:off x="11504160" y="3931920"/>
                  <a:ext cx="148284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si-BRD2+ TNFα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5" name="文本框 14"/>
                <p:cNvSpPr/>
                <p:nvPr/>
              </p:nvSpPr>
              <p:spPr>
                <a:xfrm rot="18600000">
                  <a:off x="11585880" y="3711240"/>
                  <a:ext cx="91764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si-BRD2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76" name="组合 46"/>
              <p:cNvGrpSpPr/>
              <p:nvPr/>
            </p:nvGrpSpPr>
            <p:grpSpPr>
              <a:xfrm>
                <a:off x="8934840" y="730800"/>
                <a:ext cx="1080360" cy="261360"/>
                <a:chOff x="8934840" y="730800"/>
                <a:chExt cx="1080360" cy="261360"/>
              </a:xfrm>
            </p:grpSpPr>
            <p:sp>
              <p:nvSpPr>
                <p:cNvPr id="77" name="直接连接符 47"/>
                <p:cNvSpPr/>
                <p:nvPr/>
              </p:nvSpPr>
              <p:spPr>
                <a:xfrm>
                  <a:off x="8934840" y="946800"/>
                  <a:ext cx="1080360" cy="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8" name="矩形 48"/>
                <p:cNvSpPr/>
                <p:nvPr/>
              </p:nvSpPr>
              <p:spPr>
                <a:xfrm>
                  <a:off x="9228600" y="730800"/>
                  <a:ext cx="49176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BRD3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79" name="组合 49"/>
              <p:cNvGrpSpPr/>
              <p:nvPr/>
            </p:nvGrpSpPr>
            <p:grpSpPr>
              <a:xfrm>
                <a:off x="10353600" y="730800"/>
                <a:ext cx="1080360" cy="261360"/>
                <a:chOff x="10353600" y="730800"/>
                <a:chExt cx="1080360" cy="261360"/>
              </a:xfrm>
            </p:grpSpPr>
            <p:sp>
              <p:nvSpPr>
                <p:cNvPr id="80" name="直接连接符 50"/>
                <p:cNvSpPr/>
                <p:nvPr/>
              </p:nvSpPr>
              <p:spPr>
                <a:xfrm>
                  <a:off x="10353600" y="946800"/>
                  <a:ext cx="1080360" cy="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1" name="矩形 51"/>
                <p:cNvSpPr/>
                <p:nvPr/>
              </p:nvSpPr>
              <p:spPr>
                <a:xfrm>
                  <a:off x="10647360" y="730800"/>
                  <a:ext cx="49176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BRD4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82" name="组合 52"/>
              <p:cNvGrpSpPr/>
              <p:nvPr/>
            </p:nvGrpSpPr>
            <p:grpSpPr>
              <a:xfrm>
                <a:off x="11736000" y="730800"/>
                <a:ext cx="1080360" cy="261360"/>
                <a:chOff x="11736000" y="730800"/>
                <a:chExt cx="1080360" cy="261360"/>
              </a:xfrm>
            </p:grpSpPr>
            <p:sp>
              <p:nvSpPr>
                <p:cNvPr id="83" name="直接连接符 53"/>
                <p:cNvSpPr/>
                <p:nvPr/>
              </p:nvSpPr>
              <p:spPr>
                <a:xfrm>
                  <a:off x="11736000" y="946800"/>
                  <a:ext cx="1080360" cy="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4" name="矩形 54"/>
                <p:cNvSpPr/>
                <p:nvPr/>
              </p:nvSpPr>
              <p:spPr>
                <a:xfrm>
                  <a:off x="12027240" y="730800"/>
                  <a:ext cx="5968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GAPDH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</p:grpSp>
      <p:grpSp>
        <p:nvGrpSpPr>
          <p:cNvPr id="85" name="组合 56"/>
          <p:cNvGrpSpPr/>
          <p:nvPr/>
        </p:nvGrpSpPr>
        <p:grpSpPr>
          <a:xfrm>
            <a:off x="6847920" y="5380200"/>
            <a:ext cx="5975640" cy="4033440"/>
            <a:chOff x="6847920" y="5380200"/>
            <a:chExt cx="5975640" cy="4033440"/>
          </a:xfrm>
        </p:grpSpPr>
        <p:grpSp>
          <p:nvGrpSpPr>
            <p:cNvPr id="86" name="组合 23"/>
            <p:cNvGrpSpPr/>
            <p:nvPr/>
          </p:nvGrpSpPr>
          <p:grpSpPr>
            <a:xfrm>
              <a:off x="6847920" y="8052480"/>
              <a:ext cx="1833480" cy="1359720"/>
              <a:chOff x="6847920" y="8052480"/>
              <a:chExt cx="1833480" cy="1359720"/>
            </a:xfrm>
          </p:grpSpPr>
          <p:sp>
            <p:nvSpPr>
              <p:cNvPr id="87" name="文本框 11"/>
              <p:cNvSpPr/>
              <p:nvPr/>
            </p:nvSpPr>
            <p:spPr>
              <a:xfrm rot="18600000">
                <a:off x="6894000" y="8345160"/>
                <a:ext cx="8650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1295280"/>
                    <a:tab algn="l" pos="2590920"/>
                    <a:tab algn="l" pos="3886200"/>
                    <a:tab algn="l" pos="5181480"/>
                    <a:tab algn="l" pos="6477120"/>
                    <a:tab algn="l" pos="7772400"/>
                    <a:tab algn="l" pos="9067680"/>
                    <a:tab algn="l" pos="1036332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Calibri"/>
                  </a:rPr>
                  <a:t>si-Ctrl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8" name="文本框 11"/>
              <p:cNvSpPr/>
              <p:nvPr/>
            </p:nvSpPr>
            <p:spPr>
              <a:xfrm rot="18600000">
                <a:off x="6712920" y="8509320"/>
                <a:ext cx="131472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1295280"/>
                    <a:tab algn="l" pos="2590920"/>
                    <a:tab algn="l" pos="3886200"/>
                    <a:tab algn="l" pos="5181480"/>
                    <a:tab algn="l" pos="6477120"/>
                    <a:tab algn="l" pos="7772400"/>
                    <a:tab algn="l" pos="9067680"/>
                    <a:tab algn="l" pos="1036332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Calibri"/>
                  </a:rPr>
                  <a:t>si-Ctrl + IL1β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9" name="文本框 11"/>
              <p:cNvSpPr/>
              <p:nvPr/>
            </p:nvSpPr>
            <p:spPr>
              <a:xfrm rot="18600000">
                <a:off x="6726600" y="8605080"/>
                <a:ext cx="15462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1295280"/>
                    <a:tab algn="l" pos="2590920"/>
                    <a:tab algn="l" pos="3886200"/>
                    <a:tab algn="l" pos="5181480"/>
                    <a:tab algn="l" pos="6477120"/>
                    <a:tab algn="l" pos="7772400"/>
                    <a:tab algn="l" pos="9067680"/>
                    <a:tab algn="l" pos="1036332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Calibri"/>
                  </a:rPr>
                  <a:t>si-Ctrl + TNFα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" name="文本框 14"/>
              <p:cNvSpPr/>
              <p:nvPr/>
            </p:nvSpPr>
            <p:spPr>
              <a:xfrm rot="18600000">
                <a:off x="7172640" y="8573400"/>
                <a:ext cx="14828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1295280"/>
                    <a:tab algn="l" pos="2590920"/>
                    <a:tab algn="l" pos="3886200"/>
                    <a:tab algn="l" pos="5181480"/>
                    <a:tab algn="l" pos="6477120"/>
                    <a:tab algn="l" pos="7772400"/>
                    <a:tab algn="l" pos="9067680"/>
                    <a:tab algn="l" pos="1036332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Calibri"/>
                  </a:rPr>
                  <a:t>si-BRD4+ IL1β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1" name="文本框 14"/>
              <p:cNvSpPr/>
              <p:nvPr/>
            </p:nvSpPr>
            <p:spPr>
              <a:xfrm rot="18600000">
                <a:off x="7363080" y="8580240"/>
                <a:ext cx="14828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1295280"/>
                    <a:tab algn="l" pos="2590920"/>
                    <a:tab algn="l" pos="3886200"/>
                    <a:tab algn="l" pos="5181480"/>
                    <a:tab algn="l" pos="6477120"/>
                    <a:tab algn="l" pos="7772400"/>
                    <a:tab algn="l" pos="9067680"/>
                    <a:tab algn="l" pos="1036332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Calibri"/>
                  </a:rPr>
                  <a:t>si-BRD4+ TNFα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2" name="文本框 14"/>
              <p:cNvSpPr/>
              <p:nvPr/>
            </p:nvSpPr>
            <p:spPr>
              <a:xfrm rot="18600000">
                <a:off x="7444800" y="8359560"/>
                <a:ext cx="9176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1295280"/>
                    <a:tab algn="l" pos="2590920"/>
                    <a:tab algn="l" pos="3886200"/>
                    <a:tab algn="l" pos="5181480"/>
                    <a:tab algn="l" pos="6477120"/>
                    <a:tab algn="l" pos="7772400"/>
                    <a:tab algn="l" pos="9067680"/>
                    <a:tab algn="l" pos="1036332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Calibri"/>
                  </a:rPr>
                  <a:t>si-BRD4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93" name="组合 45"/>
            <p:cNvGrpSpPr/>
            <p:nvPr/>
          </p:nvGrpSpPr>
          <p:grpSpPr>
            <a:xfrm>
              <a:off x="7561440" y="5380560"/>
              <a:ext cx="1080000" cy="261360"/>
              <a:chOff x="7561440" y="5380560"/>
              <a:chExt cx="1080000" cy="261360"/>
            </a:xfrm>
          </p:grpSpPr>
          <p:sp>
            <p:nvSpPr>
              <p:cNvPr id="94" name="直接连接符 89"/>
              <p:cNvSpPr/>
              <p:nvPr/>
            </p:nvSpPr>
            <p:spPr>
              <a:xfrm>
                <a:off x="7561440" y="5596560"/>
                <a:ext cx="1080000" cy="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5" name="矩形 90"/>
              <p:cNvSpPr/>
              <p:nvPr/>
            </p:nvSpPr>
            <p:spPr>
              <a:xfrm>
                <a:off x="7855200" y="5380560"/>
                <a:ext cx="49176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1295280"/>
                    <a:tab algn="l" pos="2590920"/>
                    <a:tab algn="l" pos="3886200"/>
                    <a:tab algn="l" pos="5181480"/>
                    <a:tab algn="l" pos="6477120"/>
                    <a:tab algn="l" pos="7772400"/>
                    <a:tab algn="l" pos="9067680"/>
                    <a:tab algn="l" pos="1036332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Calibri"/>
                  </a:rPr>
                  <a:t>BRD4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96" name="组合 24"/>
            <p:cNvGrpSpPr/>
            <p:nvPr/>
          </p:nvGrpSpPr>
          <p:grpSpPr>
            <a:xfrm>
              <a:off x="8223840" y="8053920"/>
              <a:ext cx="1833480" cy="1359720"/>
              <a:chOff x="8223840" y="8053920"/>
              <a:chExt cx="1833480" cy="1359720"/>
            </a:xfrm>
          </p:grpSpPr>
          <p:sp>
            <p:nvSpPr>
              <p:cNvPr id="97" name="文本框 11"/>
              <p:cNvSpPr/>
              <p:nvPr/>
            </p:nvSpPr>
            <p:spPr>
              <a:xfrm rot="18600000">
                <a:off x="8269920" y="8346600"/>
                <a:ext cx="8650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1295280"/>
                    <a:tab algn="l" pos="2590920"/>
                    <a:tab algn="l" pos="3886200"/>
                    <a:tab algn="l" pos="5181480"/>
                    <a:tab algn="l" pos="6477120"/>
                    <a:tab algn="l" pos="7772400"/>
                    <a:tab algn="l" pos="9067680"/>
                    <a:tab algn="l" pos="1036332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Calibri"/>
                  </a:rPr>
                  <a:t>si-Ctrl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8" name="文本框 11"/>
              <p:cNvSpPr/>
              <p:nvPr/>
            </p:nvSpPr>
            <p:spPr>
              <a:xfrm rot="18600000">
                <a:off x="8088840" y="8510760"/>
                <a:ext cx="131472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1295280"/>
                    <a:tab algn="l" pos="2590920"/>
                    <a:tab algn="l" pos="3886200"/>
                    <a:tab algn="l" pos="5181480"/>
                    <a:tab algn="l" pos="6477120"/>
                    <a:tab algn="l" pos="7772400"/>
                    <a:tab algn="l" pos="9067680"/>
                    <a:tab algn="l" pos="1036332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Calibri"/>
                  </a:rPr>
                  <a:t>si-Ctrl + IL1β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9" name="文本框 11"/>
              <p:cNvSpPr/>
              <p:nvPr/>
            </p:nvSpPr>
            <p:spPr>
              <a:xfrm rot="18600000">
                <a:off x="8102520" y="8606520"/>
                <a:ext cx="15462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1295280"/>
                    <a:tab algn="l" pos="2590920"/>
                    <a:tab algn="l" pos="3886200"/>
                    <a:tab algn="l" pos="5181480"/>
                    <a:tab algn="l" pos="6477120"/>
                    <a:tab algn="l" pos="7772400"/>
                    <a:tab algn="l" pos="9067680"/>
                    <a:tab algn="l" pos="1036332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Calibri"/>
                  </a:rPr>
                  <a:t>si-Ctrl + TNFα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0" name="文本框 14"/>
              <p:cNvSpPr/>
              <p:nvPr/>
            </p:nvSpPr>
            <p:spPr>
              <a:xfrm rot="18600000">
                <a:off x="8548560" y="8574840"/>
                <a:ext cx="14828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1295280"/>
                    <a:tab algn="l" pos="2590920"/>
                    <a:tab algn="l" pos="3886200"/>
                    <a:tab algn="l" pos="5181480"/>
                    <a:tab algn="l" pos="6477120"/>
                    <a:tab algn="l" pos="7772400"/>
                    <a:tab algn="l" pos="9067680"/>
                    <a:tab algn="l" pos="1036332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Calibri"/>
                  </a:rPr>
                  <a:t>si-BRD4+ IL1β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1" name="文本框 14"/>
              <p:cNvSpPr/>
              <p:nvPr/>
            </p:nvSpPr>
            <p:spPr>
              <a:xfrm rot="18600000">
                <a:off x="8739000" y="8581680"/>
                <a:ext cx="14828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1295280"/>
                    <a:tab algn="l" pos="2590920"/>
                    <a:tab algn="l" pos="3886200"/>
                    <a:tab algn="l" pos="5181480"/>
                    <a:tab algn="l" pos="6477120"/>
                    <a:tab algn="l" pos="7772400"/>
                    <a:tab algn="l" pos="9067680"/>
                    <a:tab algn="l" pos="1036332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Calibri"/>
                  </a:rPr>
                  <a:t>si-BRD4+ TNFα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2" name="文本框 14"/>
              <p:cNvSpPr/>
              <p:nvPr/>
            </p:nvSpPr>
            <p:spPr>
              <a:xfrm rot="18600000">
                <a:off x="8820720" y="8361000"/>
                <a:ext cx="9176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1295280"/>
                    <a:tab algn="l" pos="2590920"/>
                    <a:tab algn="l" pos="3886200"/>
                    <a:tab algn="l" pos="5181480"/>
                    <a:tab algn="l" pos="6477120"/>
                    <a:tab algn="l" pos="7772400"/>
                    <a:tab algn="l" pos="9067680"/>
                    <a:tab algn="l" pos="1036332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Calibri"/>
                  </a:rPr>
                  <a:t>si-BRD4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03" name="组合 31"/>
            <p:cNvGrpSpPr/>
            <p:nvPr/>
          </p:nvGrpSpPr>
          <p:grpSpPr>
            <a:xfrm>
              <a:off x="9607320" y="8053920"/>
              <a:ext cx="1833480" cy="1359720"/>
              <a:chOff x="9607320" y="8053920"/>
              <a:chExt cx="1833480" cy="1359720"/>
            </a:xfrm>
          </p:grpSpPr>
          <p:sp>
            <p:nvSpPr>
              <p:cNvPr id="104" name="文本框 11"/>
              <p:cNvSpPr/>
              <p:nvPr/>
            </p:nvSpPr>
            <p:spPr>
              <a:xfrm rot="18600000">
                <a:off x="9653400" y="8346600"/>
                <a:ext cx="8650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1295280"/>
                    <a:tab algn="l" pos="2590920"/>
                    <a:tab algn="l" pos="3886200"/>
                    <a:tab algn="l" pos="5181480"/>
                    <a:tab algn="l" pos="6477120"/>
                    <a:tab algn="l" pos="7772400"/>
                    <a:tab algn="l" pos="9067680"/>
                    <a:tab algn="l" pos="1036332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Calibri"/>
                  </a:rPr>
                  <a:t>si-Ctrl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5" name="文本框 11"/>
              <p:cNvSpPr/>
              <p:nvPr/>
            </p:nvSpPr>
            <p:spPr>
              <a:xfrm rot="18600000">
                <a:off x="9472320" y="8510760"/>
                <a:ext cx="131472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1295280"/>
                    <a:tab algn="l" pos="2590920"/>
                    <a:tab algn="l" pos="3886200"/>
                    <a:tab algn="l" pos="5181480"/>
                    <a:tab algn="l" pos="6477120"/>
                    <a:tab algn="l" pos="7772400"/>
                    <a:tab algn="l" pos="9067680"/>
                    <a:tab algn="l" pos="1036332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Calibri"/>
                  </a:rPr>
                  <a:t>si-Ctrl + IL1β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6" name="文本框 11"/>
              <p:cNvSpPr/>
              <p:nvPr/>
            </p:nvSpPr>
            <p:spPr>
              <a:xfrm rot="18600000">
                <a:off x="9486000" y="8606520"/>
                <a:ext cx="15462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1295280"/>
                    <a:tab algn="l" pos="2590920"/>
                    <a:tab algn="l" pos="3886200"/>
                    <a:tab algn="l" pos="5181480"/>
                    <a:tab algn="l" pos="6477120"/>
                    <a:tab algn="l" pos="7772400"/>
                    <a:tab algn="l" pos="9067680"/>
                    <a:tab algn="l" pos="1036332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Calibri"/>
                  </a:rPr>
                  <a:t>si-Ctrl + TNFα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7" name="文本框 14"/>
              <p:cNvSpPr/>
              <p:nvPr/>
            </p:nvSpPr>
            <p:spPr>
              <a:xfrm rot="18600000">
                <a:off x="9932040" y="8574840"/>
                <a:ext cx="14828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1295280"/>
                    <a:tab algn="l" pos="2590920"/>
                    <a:tab algn="l" pos="3886200"/>
                    <a:tab algn="l" pos="5181480"/>
                    <a:tab algn="l" pos="6477120"/>
                    <a:tab algn="l" pos="7772400"/>
                    <a:tab algn="l" pos="9067680"/>
                    <a:tab algn="l" pos="1036332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Calibri"/>
                  </a:rPr>
                  <a:t>si-BRD4+ IL1β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8" name="文本框 14"/>
              <p:cNvSpPr/>
              <p:nvPr/>
            </p:nvSpPr>
            <p:spPr>
              <a:xfrm rot="18600000">
                <a:off x="10122480" y="8581680"/>
                <a:ext cx="14828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1295280"/>
                    <a:tab algn="l" pos="2590920"/>
                    <a:tab algn="l" pos="3886200"/>
                    <a:tab algn="l" pos="5181480"/>
                    <a:tab algn="l" pos="6477120"/>
                    <a:tab algn="l" pos="7772400"/>
                    <a:tab algn="l" pos="9067680"/>
                    <a:tab algn="l" pos="1036332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Calibri"/>
                  </a:rPr>
                  <a:t>si-BRD4+ TNFα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9" name="文本框 14"/>
              <p:cNvSpPr/>
              <p:nvPr/>
            </p:nvSpPr>
            <p:spPr>
              <a:xfrm rot="18600000">
                <a:off x="10204200" y="8361000"/>
                <a:ext cx="9176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1295280"/>
                    <a:tab algn="l" pos="2590920"/>
                    <a:tab algn="l" pos="3886200"/>
                    <a:tab algn="l" pos="5181480"/>
                    <a:tab algn="l" pos="6477120"/>
                    <a:tab algn="l" pos="7772400"/>
                    <a:tab algn="l" pos="9067680"/>
                    <a:tab algn="l" pos="1036332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Calibri"/>
                  </a:rPr>
                  <a:t>si-BRD4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10" name="组合 38"/>
            <p:cNvGrpSpPr/>
            <p:nvPr/>
          </p:nvGrpSpPr>
          <p:grpSpPr>
            <a:xfrm>
              <a:off x="10990080" y="8053920"/>
              <a:ext cx="1833480" cy="1359720"/>
              <a:chOff x="10990080" y="8053920"/>
              <a:chExt cx="1833480" cy="1359720"/>
            </a:xfrm>
          </p:grpSpPr>
          <p:sp>
            <p:nvSpPr>
              <p:cNvPr id="111" name="文本框 11"/>
              <p:cNvSpPr/>
              <p:nvPr/>
            </p:nvSpPr>
            <p:spPr>
              <a:xfrm rot="18600000">
                <a:off x="11036160" y="8346600"/>
                <a:ext cx="8650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1295280"/>
                    <a:tab algn="l" pos="2590920"/>
                    <a:tab algn="l" pos="3886200"/>
                    <a:tab algn="l" pos="5181480"/>
                    <a:tab algn="l" pos="6477120"/>
                    <a:tab algn="l" pos="7772400"/>
                    <a:tab algn="l" pos="9067680"/>
                    <a:tab algn="l" pos="1036332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Calibri"/>
                  </a:rPr>
                  <a:t>si-Ctrl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2" name="文本框 11"/>
              <p:cNvSpPr/>
              <p:nvPr/>
            </p:nvSpPr>
            <p:spPr>
              <a:xfrm rot="18600000">
                <a:off x="10855080" y="8510760"/>
                <a:ext cx="131472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1295280"/>
                    <a:tab algn="l" pos="2590920"/>
                    <a:tab algn="l" pos="3886200"/>
                    <a:tab algn="l" pos="5181480"/>
                    <a:tab algn="l" pos="6477120"/>
                    <a:tab algn="l" pos="7772400"/>
                    <a:tab algn="l" pos="9067680"/>
                    <a:tab algn="l" pos="1036332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Calibri"/>
                  </a:rPr>
                  <a:t>si-Ctrl + IL1β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3" name="文本框 11"/>
              <p:cNvSpPr/>
              <p:nvPr/>
            </p:nvSpPr>
            <p:spPr>
              <a:xfrm rot="18600000">
                <a:off x="10868760" y="8606520"/>
                <a:ext cx="15462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1295280"/>
                    <a:tab algn="l" pos="2590920"/>
                    <a:tab algn="l" pos="3886200"/>
                    <a:tab algn="l" pos="5181480"/>
                    <a:tab algn="l" pos="6477120"/>
                    <a:tab algn="l" pos="7772400"/>
                    <a:tab algn="l" pos="9067680"/>
                    <a:tab algn="l" pos="1036332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Calibri"/>
                  </a:rPr>
                  <a:t>si-Ctrl + TNFα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4" name="文本框 14"/>
              <p:cNvSpPr/>
              <p:nvPr/>
            </p:nvSpPr>
            <p:spPr>
              <a:xfrm rot="18600000">
                <a:off x="11314800" y="8574840"/>
                <a:ext cx="14828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1295280"/>
                    <a:tab algn="l" pos="2590920"/>
                    <a:tab algn="l" pos="3886200"/>
                    <a:tab algn="l" pos="5181480"/>
                    <a:tab algn="l" pos="6477120"/>
                    <a:tab algn="l" pos="7772400"/>
                    <a:tab algn="l" pos="9067680"/>
                    <a:tab algn="l" pos="1036332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Calibri"/>
                  </a:rPr>
                  <a:t>si-BRD4+ IL1β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5" name="文本框 14"/>
              <p:cNvSpPr/>
              <p:nvPr/>
            </p:nvSpPr>
            <p:spPr>
              <a:xfrm rot="18600000">
                <a:off x="11505240" y="8581680"/>
                <a:ext cx="14828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1295280"/>
                    <a:tab algn="l" pos="2590920"/>
                    <a:tab algn="l" pos="3886200"/>
                    <a:tab algn="l" pos="5181480"/>
                    <a:tab algn="l" pos="6477120"/>
                    <a:tab algn="l" pos="7772400"/>
                    <a:tab algn="l" pos="9067680"/>
                    <a:tab algn="l" pos="1036332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Calibri"/>
                  </a:rPr>
                  <a:t>si-BRD4+ TNFα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6" name="文本框 14"/>
              <p:cNvSpPr/>
              <p:nvPr/>
            </p:nvSpPr>
            <p:spPr>
              <a:xfrm rot="18600000">
                <a:off x="11586960" y="8361000"/>
                <a:ext cx="9176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1295280"/>
                    <a:tab algn="l" pos="2590920"/>
                    <a:tab algn="l" pos="3886200"/>
                    <a:tab algn="l" pos="5181480"/>
                    <a:tab algn="l" pos="6477120"/>
                    <a:tab algn="l" pos="7772400"/>
                    <a:tab algn="l" pos="9067680"/>
                    <a:tab algn="l" pos="1036332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Calibri"/>
                  </a:rPr>
                  <a:t>si-BRD4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17" name="组合 46"/>
            <p:cNvGrpSpPr/>
            <p:nvPr/>
          </p:nvGrpSpPr>
          <p:grpSpPr>
            <a:xfrm>
              <a:off x="8935920" y="5380200"/>
              <a:ext cx="1080000" cy="261360"/>
              <a:chOff x="8935920" y="5380200"/>
              <a:chExt cx="1080000" cy="261360"/>
            </a:xfrm>
          </p:grpSpPr>
          <p:sp>
            <p:nvSpPr>
              <p:cNvPr id="118" name="直接连接符 69"/>
              <p:cNvSpPr/>
              <p:nvPr/>
            </p:nvSpPr>
            <p:spPr>
              <a:xfrm>
                <a:off x="8935920" y="5596200"/>
                <a:ext cx="1080000" cy="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9" name="矩形 70"/>
              <p:cNvSpPr/>
              <p:nvPr/>
            </p:nvSpPr>
            <p:spPr>
              <a:xfrm>
                <a:off x="9229680" y="5380200"/>
                <a:ext cx="49176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1295280"/>
                    <a:tab algn="l" pos="2590920"/>
                    <a:tab algn="l" pos="3886200"/>
                    <a:tab algn="l" pos="5181480"/>
                    <a:tab algn="l" pos="6477120"/>
                    <a:tab algn="l" pos="7772400"/>
                    <a:tab algn="l" pos="9067680"/>
                    <a:tab algn="l" pos="1036332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Calibri"/>
                  </a:rPr>
                  <a:t>BRD2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20" name="组合 49"/>
            <p:cNvGrpSpPr/>
            <p:nvPr/>
          </p:nvGrpSpPr>
          <p:grpSpPr>
            <a:xfrm>
              <a:off x="10354680" y="5380200"/>
              <a:ext cx="1080000" cy="261360"/>
              <a:chOff x="10354680" y="5380200"/>
              <a:chExt cx="1080000" cy="261360"/>
            </a:xfrm>
          </p:grpSpPr>
          <p:sp>
            <p:nvSpPr>
              <p:cNvPr id="121" name="直接连接符 67"/>
              <p:cNvSpPr/>
              <p:nvPr/>
            </p:nvSpPr>
            <p:spPr>
              <a:xfrm>
                <a:off x="10354680" y="5596200"/>
                <a:ext cx="1080000" cy="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2" name="矩形 68"/>
              <p:cNvSpPr/>
              <p:nvPr/>
            </p:nvSpPr>
            <p:spPr>
              <a:xfrm>
                <a:off x="10648440" y="5380200"/>
                <a:ext cx="49176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1295280"/>
                    <a:tab algn="l" pos="2590920"/>
                    <a:tab algn="l" pos="3886200"/>
                    <a:tab algn="l" pos="5181480"/>
                    <a:tab algn="l" pos="6477120"/>
                    <a:tab algn="l" pos="7772400"/>
                    <a:tab algn="l" pos="9067680"/>
                    <a:tab algn="l" pos="1036332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Calibri"/>
                  </a:rPr>
                  <a:t>BRD3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23" name="组合 52"/>
            <p:cNvGrpSpPr/>
            <p:nvPr/>
          </p:nvGrpSpPr>
          <p:grpSpPr>
            <a:xfrm>
              <a:off x="11737440" y="5380200"/>
              <a:ext cx="1080000" cy="261360"/>
              <a:chOff x="11737440" y="5380200"/>
              <a:chExt cx="1080000" cy="261360"/>
            </a:xfrm>
          </p:grpSpPr>
          <p:sp>
            <p:nvSpPr>
              <p:cNvPr id="124" name="直接连接符 65"/>
              <p:cNvSpPr/>
              <p:nvPr/>
            </p:nvSpPr>
            <p:spPr>
              <a:xfrm>
                <a:off x="11737440" y="5596200"/>
                <a:ext cx="1080000" cy="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5" name="矩形 66"/>
              <p:cNvSpPr/>
              <p:nvPr/>
            </p:nvSpPr>
            <p:spPr>
              <a:xfrm>
                <a:off x="12028320" y="5380200"/>
                <a:ext cx="5968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1295280"/>
                    <a:tab algn="l" pos="2590920"/>
                    <a:tab algn="l" pos="3886200"/>
                    <a:tab algn="l" pos="5181480"/>
                    <a:tab algn="l" pos="6477120"/>
                    <a:tab algn="l" pos="7772400"/>
                    <a:tab algn="l" pos="9067680"/>
                    <a:tab algn="l" pos="1036332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Calibri"/>
                  </a:rPr>
                  <a:t>GAPDH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grpSp>
        <p:nvGrpSpPr>
          <p:cNvPr id="126" name="组合 164"/>
          <p:cNvGrpSpPr/>
          <p:nvPr/>
        </p:nvGrpSpPr>
        <p:grpSpPr>
          <a:xfrm>
            <a:off x="291960" y="5272200"/>
            <a:ext cx="5975640" cy="4109400"/>
            <a:chOff x="291960" y="5272200"/>
            <a:chExt cx="5975640" cy="4109400"/>
          </a:xfrm>
        </p:grpSpPr>
        <p:pic>
          <p:nvPicPr>
            <p:cNvPr id="127" name="Picture 6" descr=""/>
            <p:cNvPicPr/>
            <p:nvPr/>
          </p:nvPicPr>
          <p:blipFill>
            <a:blip r:embed="rId3"/>
            <a:stretch/>
          </p:blipFill>
          <p:spPr>
            <a:xfrm>
              <a:off x="291960" y="5279760"/>
              <a:ext cx="5954400" cy="293724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28" name="组合 97"/>
            <p:cNvGrpSpPr/>
            <p:nvPr/>
          </p:nvGrpSpPr>
          <p:grpSpPr>
            <a:xfrm>
              <a:off x="292680" y="5272200"/>
              <a:ext cx="5974920" cy="4109400"/>
              <a:chOff x="292680" y="5272200"/>
              <a:chExt cx="5974920" cy="4109400"/>
            </a:xfrm>
          </p:grpSpPr>
          <p:grpSp>
            <p:nvGrpSpPr>
              <p:cNvPr id="129" name="组合 23"/>
              <p:cNvGrpSpPr/>
              <p:nvPr/>
            </p:nvGrpSpPr>
            <p:grpSpPr>
              <a:xfrm>
                <a:off x="292680" y="8020440"/>
                <a:ext cx="1833480" cy="1359720"/>
                <a:chOff x="292680" y="8020440"/>
                <a:chExt cx="1833480" cy="1359720"/>
              </a:xfrm>
            </p:grpSpPr>
            <p:sp>
              <p:nvSpPr>
                <p:cNvPr id="130" name="文本框 11"/>
                <p:cNvSpPr/>
                <p:nvPr/>
              </p:nvSpPr>
              <p:spPr>
                <a:xfrm rot="18600000">
                  <a:off x="338760" y="8313120"/>
                  <a:ext cx="8650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si-Ctrl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31" name="文本框 11"/>
                <p:cNvSpPr/>
                <p:nvPr/>
              </p:nvSpPr>
              <p:spPr>
                <a:xfrm rot="18600000">
                  <a:off x="157680" y="8477280"/>
                  <a:ext cx="131472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si-Ctrl + IL1β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32" name="文本框 11"/>
                <p:cNvSpPr/>
                <p:nvPr/>
              </p:nvSpPr>
              <p:spPr>
                <a:xfrm rot="18600000">
                  <a:off x="171360" y="8573040"/>
                  <a:ext cx="154620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si-Ctrl + TNFα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33" name="文本框 14"/>
                <p:cNvSpPr/>
                <p:nvPr/>
              </p:nvSpPr>
              <p:spPr>
                <a:xfrm rot="18600000">
                  <a:off x="617400" y="8541360"/>
                  <a:ext cx="148284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si-BRD3+ IL1β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34" name="文本框 14"/>
                <p:cNvSpPr/>
                <p:nvPr/>
              </p:nvSpPr>
              <p:spPr>
                <a:xfrm rot="18600000">
                  <a:off x="807840" y="8548200"/>
                  <a:ext cx="148284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si-BRD3+ TNFα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35" name="文本框 14"/>
                <p:cNvSpPr/>
                <p:nvPr/>
              </p:nvSpPr>
              <p:spPr>
                <a:xfrm rot="18600000">
                  <a:off x="889560" y="8327520"/>
                  <a:ext cx="91764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si-BRD3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136" name="组合 45"/>
              <p:cNvGrpSpPr/>
              <p:nvPr/>
            </p:nvGrpSpPr>
            <p:grpSpPr>
              <a:xfrm>
                <a:off x="1006200" y="5272560"/>
                <a:ext cx="1080000" cy="261360"/>
                <a:chOff x="1006200" y="5272560"/>
                <a:chExt cx="1080000" cy="261360"/>
              </a:xfrm>
            </p:grpSpPr>
            <p:sp>
              <p:nvSpPr>
                <p:cNvPr id="137" name="直接连接符 130"/>
                <p:cNvSpPr/>
                <p:nvPr/>
              </p:nvSpPr>
              <p:spPr>
                <a:xfrm>
                  <a:off x="1006200" y="5488560"/>
                  <a:ext cx="1080000" cy="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38" name="矩形 131"/>
                <p:cNvSpPr/>
                <p:nvPr/>
              </p:nvSpPr>
              <p:spPr>
                <a:xfrm>
                  <a:off x="1299960" y="5272560"/>
                  <a:ext cx="49176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BRD3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139" name="组合 24"/>
              <p:cNvGrpSpPr/>
              <p:nvPr/>
            </p:nvGrpSpPr>
            <p:grpSpPr>
              <a:xfrm>
                <a:off x="1668240" y="8021880"/>
                <a:ext cx="1833480" cy="1359720"/>
                <a:chOff x="1668240" y="8021880"/>
                <a:chExt cx="1833480" cy="1359720"/>
              </a:xfrm>
            </p:grpSpPr>
            <p:sp>
              <p:nvSpPr>
                <p:cNvPr id="140" name="文本框 11"/>
                <p:cNvSpPr/>
                <p:nvPr/>
              </p:nvSpPr>
              <p:spPr>
                <a:xfrm rot="18600000">
                  <a:off x="1714320" y="8314560"/>
                  <a:ext cx="8650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si-Ctrl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41" name="文本框 11"/>
                <p:cNvSpPr/>
                <p:nvPr/>
              </p:nvSpPr>
              <p:spPr>
                <a:xfrm rot="18600000">
                  <a:off x="1533240" y="8478720"/>
                  <a:ext cx="131472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si-Ctrl + IL1β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42" name="文本框 11"/>
                <p:cNvSpPr/>
                <p:nvPr/>
              </p:nvSpPr>
              <p:spPr>
                <a:xfrm rot="18600000">
                  <a:off x="1546920" y="8574480"/>
                  <a:ext cx="154620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si-Ctrl + TNFα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43" name="文本框 14"/>
                <p:cNvSpPr/>
                <p:nvPr/>
              </p:nvSpPr>
              <p:spPr>
                <a:xfrm rot="18600000">
                  <a:off x="1992960" y="8542800"/>
                  <a:ext cx="148284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si-BRD3+ IL1β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44" name="文本框 14"/>
                <p:cNvSpPr/>
                <p:nvPr/>
              </p:nvSpPr>
              <p:spPr>
                <a:xfrm rot="18600000">
                  <a:off x="2183400" y="8549640"/>
                  <a:ext cx="148284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si-BRD3+ TNFα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45" name="文本框 14"/>
                <p:cNvSpPr/>
                <p:nvPr/>
              </p:nvSpPr>
              <p:spPr>
                <a:xfrm rot="18600000">
                  <a:off x="2265120" y="8328960"/>
                  <a:ext cx="91764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si-BRD3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146" name="组合 31"/>
              <p:cNvGrpSpPr/>
              <p:nvPr/>
            </p:nvGrpSpPr>
            <p:grpSpPr>
              <a:xfrm>
                <a:off x="3051360" y="8021880"/>
                <a:ext cx="1833480" cy="1359720"/>
                <a:chOff x="3051360" y="8021880"/>
                <a:chExt cx="1833480" cy="1359720"/>
              </a:xfrm>
            </p:grpSpPr>
            <p:sp>
              <p:nvSpPr>
                <p:cNvPr id="147" name="文本框 11"/>
                <p:cNvSpPr/>
                <p:nvPr/>
              </p:nvSpPr>
              <p:spPr>
                <a:xfrm rot="18600000">
                  <a:off x="3097440" y="8314560"/>
                  <a:ext cx="8650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si-Ctrl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48" name="文本框 11"/>
                <p:cNvSpPr/>
                <p:nvPr/>
              </p:nvSpPr>
              <p:spPr>
                <a:xfrm rot="18600000">
                  <a:off x="2916360" y="8478720"/>
                  <a:ext cx="131472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si-Ctrl + IL1β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49" name="文本框 11"/>
                <p:cNvSpPr/>
                <p:nvPr/>
              </p:nvSpPr>
              <p:spPr>
                <a:xfrm rot="18600000">
                  <a:off x="2930040" y="8574480"/>
                  <a:ext cx="154620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si-Ctrl + TNFα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50" name="文本框 14"/>
                <p:cNvSpPr/>
                <p:nvPr/>
              </p:nvSpPr>
              <p:spPr>
                <a:xfrm rot="18600000">
                  <a:off x="3376080" y="8542800"/>
                  <a:ext cx="148284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si-BRD3+ IL1β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51" name="文本框 14"/>
                <p:cNvSpPr/>
                <p:nvPr/>
              </p:nvSpPr>
              <p:spPr>
                <a:xfrm rot="18600000">
                  <a:off x="3566520" y="8549640"/>
                  <a:ext cx="148284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si-BRD3+ TNFα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52" name="文本框 14"/>
                <p:cNvSpPr/>
                <p:nvPr/>
              </p:nvSpPr>
              <p:spPr>
                <a:xfrm rot="18600000">
                  <a:off x="3648240" y="8328960"/>
                  <a:ext cx="91764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si-BRD3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153" name="组合 38"/>
              <p:cNvGrpSpPr/>
              <p:nvPr/>
            </p:nvGrpSpPr>
            <p:grpSpPr>
              <a:xfrm>
                <a:off x="4434120" y="8021880"/>
                <a:ext cx="1833480" cy="1359720"/>
                <a:chOff x="4434120" y="8021880"/>
                <a:chExt cx="1833480" cy="1359720"/>
              </a:xfrm>
            </p:grpSpPr>
            <p:sp>
              <p:nvSpPr>
                <p:cNvPr id="154" name="文本框 11"/>
                <p:cNvSpPr/>
                <p:nvPr/>
              </p:nvSpPr>
              <p:spPr>
                <a:xfrm rot="18600000">
                  <a:off x="4480200" y="8314560"/>
                  <a:ext cx="8650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si-Ctrl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55" name="文本框 11"/>
                <p:cNvSpPr/>
                <p:nvPr/>
              </p:nvSpPr>
              <p:spPr>
                <a:xfrm rot="18600000">
                  <a:off x="4299120" y="8478720"/>
                  <a:ext cx="131472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si-Ctrl + IL1β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56" name="文本框 11"/>
                <p:cNvSpPr/>
                <p:nvPr/>
              </p:nvSpPr>
              <p:spPr>
                <a:xfrm rot="18600000">
                  <a:off x="4312800" y="8574480"/>
                  <a:ext cx="154620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si-Ctrl + TNFα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57" name="文本框 14"/>
                <p:cNvSpPr/>
                <p:nvPr/>
              </p:nvSpPr>
              <p:spPr>
                <a:xfrm rot="18600000">
                  <a:off x="4758840" y="8542800"/>
                  <a:ext cx="148284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si-BRD3+ IL1β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58" name="文本框 14"/>
                <p:cNvSpPr/>
                <p:nvPr/>
              </p:nvSpPr>
              <p:spPr>
                <a:xfrm rot="18600000">
                  <a:off x="4949280" y="8549640"/>
                  <a:ext cx="148284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si-BRD3+ TNFα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59" name="文本框 14"/>
                <p:cNvSpPr/>
                <p:nvPr/>
              </p:nvSpPr>
              <p:spPr>
                <a:xfrm rot="18600000">
                  <a:off x="5031000" y="8328960"/>
                  <a:ext cx="91764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si-BRD3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160" name="组合 46"/>
              <p:cNvGrpSpPr/>
              <p:nvPr/>
            </p:nvGrpSpPr>
            <p:grpSpPr>
              <a:xfrm>
                <a:off x="2380320" y="5272200"/>
                <a:ext cx="1080000" cy="261360"/>
                <a:chOff x="2380320" y="5272200"/>
                <a:chExt cx="1080000" cy="261360"/>
              </a:xfrm>
            </p:grpSpPr>
            <p:sp>
              <p:nvSpPr>
                <p:cNvPr id="161" name="直接连接符 110"/>
                <p:cNvSpPr/>
                <p:nvPr/>
              </p:nvSpPr>
              <p:spPr>
                <a:xfrm>
                  <a:off x="2380320" y="5488200"/>
                  <a:ext cx="1080000" cy="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62" name="矩形 111"/>
                <p:cNvSpPr/>
                <p:nvPr/>
              </p:nvSpPr>
              <p:spPr>
                <a:xfrm>
                  <a:off x="2674080" y="5272200"/>
                  <a:ext cx="49176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BRD2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163" name="组合 49"/>
              <p:cNvGrpSpPr/>
              <p:nvPr/>
            </p:nvGrpSpPr>
            <p:grpSpPr>
              <a:xfrm>
                <a:off x="3798720" y="5272200"/>
                <a:ext cx="1080000" cy="261360"/>
                <a:chOff x="3798720" y="5272200"/>
                <a:chExt cx="1080000" cy="261360"/>
              </a:xfrm>
            </p:grpSpPr>
            <p:sp>
              <p:nvSpPr>
                <p:cNvPr id="164" name="直接连接符 108"/>
                <p:cNvSpPr/>
                <p:nvPr/>
              </p:nvSpPr>
              <p:spPr>
                <a:xfrm>
                  <a:off x="3798720" y="5488200"/>
                  <a:ext cx="1080000" cy="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65" name="矩形 109"/>
                <p:cNvSpPr/>
                <p:nvPr/>
              </p:nvSpPr>
              <p:spPr>
                <a:xfrm>
                  <a:off x="4092480" y="5272200"/>
                  <a:ext cx="49176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BRD4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166" name="组合 52"/>
              <p:cNvGrpSpPr/>
              <p:nvPr/>
            </p:nvGrpSpPr>
            <p:grpSpPr>
              <a:xfrm>
                <a:off x="5181120" y="5272200"/>
                <a:ext cx="1080000" cy="261360"/>
                <a:chOff x="5181120" y="5272200"/>
                <a:chExt cx="1080000" cy="261360"/>
              </a:xfrm>
            </p:grpSpPr>
            <p:sp>
              <p:nvSpPr>
                <p:cNvPr id="167" name="直接连接符 106"/>
                <p:cNvSpPr/>
                <p:nvPr/>
              </p:nvSpPr>
              <p:spPr>
                <a:xfrm>
                  <a:off x="5181120" y="5488200"/>
                  <a:ext cx="1080000" cy="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68" name="矩形 107"/>
                <p:cNvSpPr/>
                <p:nvPr/>
              </p:nvSpPr>
              <p:spPr>
                <a:xfrm>
                  <a:off x="5472000" y="5272200"/>
                  <a:ext cx="5968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1295280"/>
                      <a:tab algn="l" pos="2590920"/>
                      <a:tab algn="l" pos="3886200"/>
                      <a:tab algn="l" pos="5181480"/>
                      <a:tab algn="l" pos="6477120"/>
                      <a:tab algn="l" pos="7772400"/>
                      <a:tab algn="l" pos="9067680"/>
                      <a:tab algn="l" pos="1036332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GAPDH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</p:grpSp>
      <p:grpSp>
        <p:nvGrpSpPr>
          <p:cNvPr id="169" name="组合 160"/>
          <p:cNvGrpSpPr/>
          <p:nvPr/>
        </p:nvGrpSpPr>
        <p:grpSpPr>
          <a:xfrm>
            <a:off x="17280" y="612720"/>
            <a:ext cx="3215160" cy="4099680"/>
            <a:chOff x="17280" y="612720"/>
            <a:chExt cx="3215160" cy="4099680"/>
          </a:xfrm>
        </p:grpSpPr>
        <p:pic>
          <p:nvPicPr>
            <p:cNvPr id="170" name="Picture 4" descr=""/>
            <p:cNvPicPr/>
            <p:nvPr/>
          </p:nvPicPr>
          <p:blipFill>
            <a:blip r:embed="rId4"/>
            <a:stretch/>
          </p:blipFill>
          <p:spPr>
            <a:xfrm>
              <a:off x="289080" y="612720"/>
              <a:ext cx="2856600" cy="29833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71" name="组合 140"/>
            <p:cNvGrpSpPr/>
            <p:nvPr/>
          </p:nvGrpSpPr>
          <p:grpSpPr>
            <a:xfrm>
              <a:off x="17280" y="3400200"/>
              <a:ext cx="1343520" cy="1310760"/>
              <a:chOff x="17280" y="3400200"/>
              <a:chExt cx="1343520" cy="1310760"/>
            </a:xfrm>
          </p:grpSpPr>
          <p:sp>
            <p:nvSpPr>
              <p:cNvPr id="172" name="文本框 14"/>
              <p:cNvSpPr/>
              <p:nvPr/>
            </p:nvSpPr>
            <p:spPr>
              <a:xfrm rot="18600000">
                <a:off x="-147240" y="3921120"/>
                <a:ext cx="14828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1295280"/>
                    <a:tab algn="l" pos="2590920"/>
                    <a:tab algn="l" pos="3886200"/>
                    <a:tab algn="l" pos="5181480"/>
                    <a:tab algn="l" pos="6477120"/>
                    <a:tab algn="l" pos="7772400"/>
                    <a:tab algn="l" pos="9067680"/>
                    <a:tab algn="l" pos="1036332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Calibri"/>
                  </a:rPr>
                  <a:t>SW1353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3" name="文本框 14"/>
              <p:cNvSpPr/>
              <p:nvPr/>
            </p:nvSpPr>
            <p:spPr>
              <a:xfrm rot="18600000">
                <a:off x="42480" y="3927960"/>
                <a:ext cx="14828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1295280"/>
                    <a:tab algn="l" pos="2590920"/>
                    <a:tab algn="l" pos="3886200"/>
                    <a:tab algn="l" pos="5181480"/>
                    <a:tab algn="l" pos="6477120"/>
                    <a:tab algn="l" pos="7772400"/>
                    <a:tab algn="l" pos="9067680"/>
                    <a:tab algn="l" pos="1036332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Calibri"/>
                  </a:rPr>
                  <a:t>PHC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74" name="组合 141"/>
            <p:cNvGrpSpPr/>
            <p:nvPr/>
          </p:nvGrpSpPr>
          <p:grpSpPr>
            <a:xfrm>
              <a:off x="599760" y="3401640"/>
              <a:ext cx="1343520" cy="1310760"/>
              <a:chOff x="599760" y="3401640"/>
              <a:chExt cx="1343520" cy="1310760"/>
            </a:xfrm>
          </p:grpSpPr>
          <p:sp>
            <p:nvSpPr>
              <p:cNvPr id="175" name="文本框 14"/>
              <p:cNvSpPr/>
              <p:nvPr/>
            </p:nvSpPr>
            <p:spPr>
              <a:xfrm rot="18600000">
                <a:off x="434880" y="3922560"/>
                <a:ext cx="14828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1295280"/>
                    <a:tab algn="l" pos="2590920"/>
                    <a:tab algn="l" pos="3886200"/>
                    <a:tab algn="l" pos="5181480"/>
                    <a:tab algn="l" pos="6477120"/>
                    <a:tab algn="l" pos="7772400"/>
                    <a:tab algn="l" pos="9067680"/>
                    <a:tab algn="l" pos="1036332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Calibri"/>
                  </a:rPr>
                  <a:t>SW1353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6" name="文本框 14"/>
              <p:cNvSpPr/>
              <p:nvPr/>
            </p:nvSpPr>
            <p:spPr>
              <a:xfrm rot="18600000">
                <a:off x="624960" y="3929400"/>
                <a:ext cx="14828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1295280"/>
                    <a:tab algn="l" pos="2590920"/>
                    <a:tab algn="l" pos="3886200"/>
                    <a:tab algn="l" pos="5181480"/>
                    <a:tab algn="l" pos="6477120"/>
                    <a:tab algn="l" pos="7772400"/>
                    <a:tab algn="l" pos="9067680"/>
                    <a:tab algn="l" pos="1036332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Calibri"/>
                  </a:rPr>
                  <a:t>PHC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77" name="组合 144"/>
            <p:cNvGrpSpPr/>
            <p:nvPr/>
          </p:nvGrpSpPr>
          <p:grpSpPr>
            <a:xfrm>
              <a:off x="1187640" y="3401640"/>
              <a:ext cx="1343520" cy="1310760"/>
              <a:chOff x="1187640" y="3401640"/>
              <a:chExt cx="1343520" cy="1310760"/>
            </a:xfrm>
          </p:grpSpPr>
          <p:sp>
            <p:nvSpPr>
              <p:cNvPr id="178" name="文本框 14"/>
              <p:cNvSpPr/>
              <p:nvPr/>
            </p:nvSpPr>
            <p:spPr>
              <a:xfrm rot="18600000">
                <a:off x="1022760" y="3922560"/>
                <a:ext cx="14828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1295280"/>
                    <a:tab algn="l" pos="2590920"/>
                    <a:tab algn="l" pos="3886200"/>
                    <a:tab algn="l" pos="5181480"/>
                    <a:tab algn="l" pos="6477120"/>
                    <a:tab algn="l" pos="7772400"/>
                    <a:tab algn="l" pos="9067680"/>
                    <a:tab algn="l" pos="1036332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Calibri"/>
                  </a:rPr>
                  <a:t>SW1353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9" name="文本框 14"/>
              <p:cNvSpPr/>
              <p:nvPr/>
            </p:nvSpPr>
            <p:spPr>
              <a:xfrm rot="18600000">
                <a:off x="1212840" y="3929400"/>
                <a:ext cx="14828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1295280"/>
                    <a:tab algn="l" pos="2590920"/>
                    <a:tab algn="l" pos="3886200"/>
                    <a:tab algn="l" pos="5181480"/>
                    <a:tab algn="l" pos="6477120"/>
                    <a:tab algn="l" pos="7772400"/>
                    <a:tab algn="l" pos="9067680"/>
                    <a:tab algn="l" pos="1036332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Calibri"/>
                  </a:rPr>
                  <a:t>PHC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80" name="组合 147"/>
            <p:cNvGrpSpPr/>
            <p:nvPr/>
          </p:nvGrpSpPr>
          <p:grpSpPr>
            <a:xfrm>
              <a:off x="1778760" y="3401640"/>
              <a:ext cx="1343520" cy="1310760"/>
              <a:chOff x="1778760" y="3401640"/>
              <a:chExt cx="1343520" cy="1310760"/>
            </a:xfrm>
          </p:grpSpPr>
          <p:sp>
            <p:nvSpPr>
              <p:cNvPr id="181" name="文本框 14"/>
              <p:cNvSpPr/>
              <p:nvPr/>
            </p:nvSpPr>
            <p:spPr>
              <a:xfrm rot="18600000">
                <a:off x="1613880" y="3922560"/>
                <a:ext cx="14828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1295280"/>
                    <a:tab algn="l" pos="2590920"/>
                    <a:tab algn="l" pos="3886200"/>
                    <a:tab algn="l" pos="5181480"/>
                    <a:tab algn="l" pos="6477120"/>
                    <a:tab algn="l" pos="7772400"/>
                    <a:tab algn="l" pos="9067680"/>
                    <a:tab algn="l" pos="1036332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Calibri"/>
                  </a:rPr>
                  <a:t>SW1353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2" name="文本框 14"/>
              <p:cNvSpPr/>
              <p:nvPr/>
            </p:nvSpPr>
            <p:spPr>
              <a:xfrm rot="18600000">
                <a:off x="1803960" y="3929400"/>
                <a:ext cx="14828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1295280"/>
                    <a:tab algn="l" pos="2590920"/>
                    <a:tab algn="l" pos="3886200"/>
                    <a:tab algn="l" pos="5181480"/>
                    <a:tab algn="l" pos="6477120"/>
                    <a:tab algn="l" pos="7772400"/>
                    <a:tab algn="l" pos="9067680"/>
                    <a:tab algn="l" pos="1036332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Calibri"/>
                  </a:rPr>
                  <a:t>PHC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83" name="直接连接符 150"/>
            <p:cNvSpPr/>
            <p:nvPr/>
          </p:nvSpPr>
          <p:spPr>
            <a:xfrm>
              <a:off x="1008720" y="901080"/>
              <a:ext cx="2876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4" name="矩形 151"/>
            <p:cNvSpPr/>
            <p:nvPr/>
          </p:nvSpPr>
          <p:spPr>
            <a:xfrm>
              <a:off x="932040" y="685080"/>
              <a:ext cx="4917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1295280"/>
                  <a:tab algn="l" pos="2590920"/>
                  <a:tab algn="l" pos="3886200"/>
                  <a:tab algn="l" pos="5181480"/>
                  <a:tab algn="l" pos="6477120"/>
                  <a:tab algn="l" pos="7772400"/>
                  <a:tab algn="l" pos="9067680"/>
                  <a:tab algn="l" pos="1036332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</a:rPr>
                <a:t>BRD2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5" name="直接连接符 152"/>
            <p:cNvSpPr/>
            <p:nvPr/>
          </p:nvSpPr>
          <p:spPr>
            <a:xfrm>
              <a:off x="1616760" y="900720"/>
              <a:ext cx="2876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6" name="矩形 153"/>
            <p:cNvSpPr/>
            <p:nvPr/>
          </p:nvSpPr>
          <p:spPr>
            <a:xfrm>
              <a:off x="1518840" y="684720"/>
              <a:ext cx="4917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1295280"/>
                  <a:tab algn="l" pos="2590920"/>
                  <a:tab algn="l" pos="3886200"/>
                  <a:tab algn="l" pos="5181480"/>
                  <a:tab algn="l" pos="6477120"/>
                  <a:tab algn="l" pos="7772400"/>
                  <a:tab algn="l" pos="9067680"/>
                  <a:tab algn="l" pos="1036332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</a:rPr>
                <a:t>BRD3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7" name="直接连接符 154"/>
            <p:cNvSpPr/>
            <p:nvPr/>
          </p:nvSpPr>
          <p:spPr>
            <a:xfrm>
              <a:off x="2200680" y="900720"/>
              <a:ext cx="2876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8" name="矩形 155"/>
            <p:cNvSpPr/>
            <p:nvPr/>
          </p:nvSpPr>
          <p:spPr>
            <a:xfrm>
              <a:off x="2115720" y="684720"/>
              <a:ext cx="4917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1295280"/>
                  <a:tab algn="l" pos="2590920"/>
                  <a:tab algn="l" pos="3886200"/>
                  <a:tab algn="l" pos="5181480"/>
                  <a:tab algn="l" pos="6477120"/>
                  <a:tab algn="l" pos="7772400"/>
                  <a:tab algn="l" pos="9067680"/>
                  <a:tab algn="l" pos="1036332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</a:rPr>
                <a:t>BRD4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9" name="直接连接符 156"/>
            <p:cNvSpPr/>
            <p:nvPr/>
          </p:nvSpPr>
          <p:spPr>
            <a:xfrm>
              <a:off x="2768400" y="900720"/>
              <a:ext cx="2876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0" name="矩形 157"/>
            <p:cNvSpPr/>
            <p:nvPr/>
          </p:nvSpPr>
          <p:spPr>
            <a:xfrm>
              <a:off x="2635560" y="684720"/>
              <a:ext cx="5968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1295280"/>
                  <a:tab algn="l" pos="2590920"/>
                  <a:tab algn="l" pos="3886200"/>
                  <a:tab algn="l" pos="5181480"/>
                  <a:tab algn="l" pos="6477120"/>
                  <a:tab algn="l" pos="7772400"/>
                  <a:tab algn="l" pos="9067680"/>
                  <a:tab algn="l" pos="1036332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</a:rPr>
                <a:t>GAPDH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91" name="文本框 42"/>
          <p:cNvSpPr/>
          <p:nvPr/>
        </p:nvSpPr>
        <p:spPr>
          <a:xfrm rot="16200000">
            <a:off x="-827280" y="6767280"/>
            <a:ext cx="19573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Calibri"/>
              </a:rPr>
              <a:t>Relative densitometry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2" name="文本框 42"/>
          <p:cNvSpPr/>
          <p:nvPr/>
        </p:nvSpPr>
        <p:spPr>
          <a:xfrm rot="16200000">
            <a:off x="-827280" y="2016000"/>
            <a:ext cx="19573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Calibri"/>
              </a:rPr>
              <a:t>Relative densitometry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3" name="文本框 42"/>
          <p:cNvSpPr/>
          <p:nvPr/>
        </p:nvSpPr>
        <p:spPr>
          <a:xfrm rot="16200000">
            <a:off x="5687640" y="6767280"/>
            <a:ext cx="19573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Calibri"/>
              </a:rPr>
              <a:t>Relative densitometry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4" name="文本框 42"/>
          <p:cNvSpPr/>
          <p:nvPr/>
        </p:nvSpPr>
        <p:spPr>
          <a:xfrm rot="16200000">
            <a:off x="5687640" y="2016000"/>
            <a:ext cx="19573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Calibri"/>
              </a:rPr>
              <a:t>Relative densitometry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5" name="文本框 53"/>
          <p:cNvSpPr/>
          <p:nvPr/>
        </p:nvSpPr>
        <p:spPr>
          <a:xfrm>
            <a:off x="6611760" y="360360"/>
            <a:ext cx="5893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6" name="文本框 53"/>
          <p:cNvSpPr/>
          <p:nvPr/>
        </p:nvSpPr>
        <p:spPr>
          <a:xfrm>
            <a:off x="133200" y="5005440"/>
            <a:ext cx="587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7" name="文本框 53"/>
          <p:cNvSpPr/>
          <p:nvPr/>
        </p:nvSpPr>
        <p:spPr>
          <a:xfrm>
            <a:off x="6611760" y="5005440"/>
            <a:ext cx="5893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Calibri"/>
              </a:rPr>
              <a:t>D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8" name="文本框 13"/>
          <p:cNvSpPr/>
          <p:nvPr/>
        </p:nvSpPr>
        <p:spPr>
          <a:xfrm>
            <a:off x="135000" y="360360"/>
            <a:ext cx="458640" cy="311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44000" rIns="144000" tIns="72000" bIns="72000" anchor="t">
            <a:spAutoFit/>
          </a:bodyPr>
          <a:p>
            <a:pPr>
              <a:tabLst>
                <a:tab algn="l" pos="0"/>
                <a:tab algn="l" pos="1295280"/>
                <a:tab algn="l" pos="2590920"/>
                <a:tab algn="l" pos="3886200"/>
                <a:tab algn="l" pos="5181480"/>
                <a:tab algn="l" pos="6477120"/>
                <a:tab algn="l" pos="7772400"/>
                <a:tab algn="l" pos="9067680"/>
                <a:tab algn="l" pos="1036332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User</cp:lastModifiedBy>
  <dcterms:modified xsi:type="dcterms:W3CDTF">2018-09-16T08:50:45Z</dcterms:modified>
  <cp:revision>4</cp:revision>
  <dc:subject/>
  <dc:title>幻灯片 1</dc:title>
</cp:coreProperties>
</file>